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9"/>
  </p:normalViewPr>
  <p:slideViewPr>
    <p:cSldViewPr>
      <p:cViewPr varScale="1">
        <p:scale>
          <a:sx n="80" d="100"/>
          <a:sy n="80" d="100"/>
        </p:scale>
        <p:origin x="-1493" y="-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F$3</c:f>
              <c:strCache>
                <c:ptCount val="1"/>
                <c:pt idx="0">
                  <c:v>No of events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E$4:$E$8</c:f>
              <c:strCache>
                <c:ptCount val="5"/>
                <c:pt idx="0">
                  <c:v>&lt;100 bp</c:v>
                </c:pt>
                <c:pt idx="1">
                  <c:v>100-1000 bp</c:v>
                </c:pt>
                <c:pt idx="2">
                  <c:v>1-10 Kb</c:v>
                </c:pt>
                <c:pt idx="3">
                  <c:v>10-100 Kb</c:v>
                </c:pt>
                <c:pt idx="4">
                  <c:v>&gt;100 Kb</c:v>
                </c:pt>
              </c:strCache>
            </c:strRef>
          </c:cat>
          <c:val>
            <c:numRef>
              <c:f>Sheet1!$F$4:$F$8</c:f>
              <c:numCache>
                <c:formatCode>General</c:formatCode>
                <c:ptCount val="5"/>
                <c:pt idx="0">
                  <c:v>1</c:v>
                </c:pt>
                <c:pt idx="1">
                  <c:v>12</c:v>
                </c:pt>
                <c:pt idx="2">
                  <c:v>45</c:v>
                </c:pt>
                <c:pt idx="3">
                  <c:v>55</c:v>
                </c:pt>
                <c:pt idx="4">
                  <c:v>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7483264"/>
        <c:axId val="131977600"/>
      </c:barChart>
      <c:catAx>
        <c:axId val="374832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ract size clas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977600"/>
        <c:crosses val="autoZero"/>
        <c:auto val="1"/>
        <c:lblAlgn val="ctr"/>
        <c:lblOffset val="100"/>
        <c:noMultiLvlLbl val="0"/>
      </c:catAx>
      <c:valAx>
        <c:axId val="131977600"/>
        <c:scaling>
          <c:orientation val="minMax"/>
          <c:max val="6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.</a:t>
                </a:r>
                <a:r>
                  <a:rPr lang="en-US" sz="1200" b="1" baseline="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2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f events</a:t>
                </a:r>
                <a:endParaRPr lang="en-US" sz="12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483264"/>
        <c:crosses val="autoZero"/>
        <c:crossBetween val="between"/>
        <c:majorUnit val="20"/>
        <c:min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222995183854444"/>
          <c:y val="5.7902343573523751E-2"/>
          <c:w val="0.83810446024344043"/>
          <c:h val="0.686379851808132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I$3</c:f>
              <c:strCache>
                <c:ptCount val="1"/>
                <c:pt idx="0">
                  <c:v>V1_57; V2_57 and V4_57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H$4:$H$8</c:f>
              <c:strCache>
                <c:ptCount val="5"/>
                <c:pt idx="0">
                  <c:v>&lt;100 bp</c:v>
                </c:pt>
                <c:pt idx="1">
                  <c:v>100-1000 bp</c:v>
                </c:pt>
                <c:pt idx="2">
                  <c:v>1-10 Kb</c:v>
                </c:pt>
                <c:pt idx="3">
                  <c:v>10-100 Kb</c:v>
                </c:pt>
                <c:pt idx="4">
                  <c:v>&gt;100 Kb</c:v>
                </c:pt>
              </c:strCache>
            </c:strRef>
          </c:cat>
          <c:val>
            <c:numRef>
              <c:f>Sheet1!$I$4:$I$8</c:f>
              <c:numCache>
                <c:formatCode>General</c:formatCode>
                <c:ptCount val="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4</c:v>
                </c:pt>
                <c:pt idx="4">
                  <c:v>2</c:v>
                </c:pt>
              </c:numCache>
            </c:numRef>
          </c:val>
        </c:ser>
        <c:ser>
          <c:idx val="1"/>
          <c:order val="1"/>
          <c:tx>
            <c:strRef>
              <c:f>Sheet1!$J$3</c:f>
              <c:strCache>
                <c:ptCount val="1"/>
                <c:pt idx="0">
                  <c:v>V3_57 and V5_57</c:v>
                </c:pt>
              </c:strCache>
            </c:strRef>
          </c:tx>
          <c:spPr>
            <a:pattFill prst="dk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H$4:$H$8</c:f>
              <c:strCache>
                <c:ptCount val="5"/>
                <c:pt idx="0">
                  <c:v>&lt;100 bp</c:v>
                </c:pt>
                <c:pt idx="1">
                  <c:v>100-1000 bp</c:v>
                </c:pt>
                <c:pt idx="2">
                  <c:v>1-10 Kb</c:v>
                </c:pt>
                <c:pt idx="3">
                  <c:v>10-100 Kb</c:v>
                </c:pt>
                <c:pt idx="4">
                  <c:v>&gt;100 Kb</c:v>
                </c:pt>
              </c:strCache>
            </c:strRef>
          </c:cat>
          <c:val>
            <c:numRef>
              <c:f>Sheet1!$J$4:$J$8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37</c:v>
                </c:pt>
                <c:pt idx="3">
                  <c:v>51</c:v>
                </c:pt>
                <c:pt idx="4">
                  <c:v>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7784576"/>
        <c:axId val="37984128"/>
      </c:barChart>
      <c:catAx>
        <c:axId val="37784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ract size clas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984128"/>
        <c:crosses val="autoZero"/>
        <c:auto val="1"/>
        <c:lblAlgn val="ctr"/>
        <c:lblOffset val="100"/>
        <c:noMultiLvlLbl val="0"/>
      </c:catAx>
      <c:valAx>
        <c:axId val="379841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. </a:t>
                </a: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f events</a:t>
                </a:r>
              </a:p>
            </c:rich>
          </c:tx>
          <c:layout>
            <c:manualLayout>
              <c:xMode val="edge"/>
              <c:yMode val="edge"/>
              <c:x val="3.0555555555555555E-2"/>
              <c:y val="0.1988350728214191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784576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9731077304657307"/>
          <c:y val="3.6156428341394202E-2"/>
          <c:w val="0.72484973753280835"/>
          <c:h val="9.30509866832012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7-07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39480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7-07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10791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7-07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69822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7-07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08443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7-07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03185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7-07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07919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7-07-2017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4873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7-07-2017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5270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7-07-2017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66966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7-07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87372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7-07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68031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5FCD37-34A4-4EC6-B513-765FB092571D}" type="datetimeFigureOut">
              <a:rPr lang="en-IN" smtClean="0"/>
              <a:t>17-07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24784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4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-36512" y="6611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-36512" y="374374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9558" y="6165304"/>
            <a:ext cx="883492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 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A) SNP segregation in haploid spores derived from four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_57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lines. 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,C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) Classification of LOH events in the vegetative lines based on tract sizes for all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_57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lines (B) or separately for V57_1, V57_2, V57_4 and V57_3, V57_5 (C).   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592" y="66110"/>
            <a:ext cx="7272808" cy="3599688"/>
          </a:xfrm>
          <a:prstGeom prst="rect">
            <a:avLst/>
          </a:prstGeom>
        </p:spPr>
      </p:pic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5057644"/>
              </p:ext>
            </p:extLst>
          </p:nvPr>
        </p:nvGraphicFramePr>
        <p:xfrm>
          <a:off x="215881" y="3901748"/>
          <a:ext cx="4411033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3891187"/>
              </p:ext>
            </p:extLst>
          </p:nvPr>
        </p:nvGraphicFramePr>
        <p:xfrm>
          <a:off x="4722862" y="3861048"/>
          <a:ext cx="4421138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18365" y="374374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9078445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8</TotalTime>
  <Words>68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ISRTVM</dc:creator>
  <cp:lastModifiedBy>IISRTVM</cp:lastModifiedBy>
  <cp:revision>47</cp:revision>
  <dcterms:created xsi:type="dcterms:W3CDTF">2015-06-08T09:59:35Z</dcterms:created>
  <dcterms:modified xsi:type="dcterms:W3CDTF">2017-07-17T11:59:51Z</dcterms:modified>
</cp:coreProperties>
</file>